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9" r:id="rId3"/>
    <p:sldId id="256" r:id="rId4"/>
    <p:sldId id="257" r:id="rId5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975" autoAdjust="0"/>
    <p:restoredTop sz="94660"/>
  </p:normalViewPr>
  <p:slideViewPr>
    <p:cSldViewPr snapToGrid="0">
      <p:cViewPr>
        <p:scale>
          <a:sx n="100" d="100"/>
          <a:sy n="100" d="100"/>
        </p:scale>
        <p:origin x="822" y="4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3433663749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485425417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30005844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5" r:id="rId2"/>
  </p:sldLayoutIdLst>
  <p:timing>
    <p:tnLst>
      <p:par>
        <p:cTn id="1" dur="indefinite" restart="never" nodeType="tmRoot"/>
      </p:par>
    </p:tnLst>
  </p:timing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90127145"/>
              </p:ext>
            </p:extLst>
          </p:nvPr>
        </p:nvGraphicFramePr>
        <p:xfrm>
          <a:off x="2875005" y="1710896"/>
          <a:ext cx="6552000" cy="327088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412000"/>
                <a:gridCol w="864000"/>
                <a:gridCol w="2412000"/>
                <a:gridCol w="864000"/>
              </a:tblGrid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olvent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s</a:t>
                      </a:r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No.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olvent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s</a:t>
                      </a:r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No.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,1,2,2-Tetrabromoethan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9-27-6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thanolamin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1-43-5 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,4-Dioxan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‎</a:t>
                      </a:r>
                      <a:r>
                        <a:rPr lang="en-US" altLang="ja-JP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3-91-1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thyl Acetat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1-78-6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-Butanol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1-36-3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thylene Glycol </a:t>
                      </a:r>
                      <a:r>
                        <a:rPr lang="en-US" sz="12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nobutyl</a:t>
                      </a:r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Ether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1-76-2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etic Acid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4-19-7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mamid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5-12-7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eton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7-64-1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thanol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7-56-1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etonitril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5-05-8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thyl Isobutyl Keton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8-10-1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llyl Alcohol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7-18-6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itrobenzen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8-95-3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ilin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2-53-3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-Methyl </a:t>
                      </a:r>
                      <a:r>
                        <a:rPr lang="en-US" sz="12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mamid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3-39-7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rbon Disulfid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5-15-0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-Methyl-2-Pyrrolidon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72-50-4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loroform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7-66-3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-</a:t>
                      </a:r>
                      <a:r>
                        <a:rPr lang="en-US" sz="12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thylanilin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0-61-8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clohexanon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8-94-1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ctan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1-65-9 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ethylene Glycol Monomethyl Ether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1-77-3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yridin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0-86-1 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methyl </a:t>
                      </a:r>
                      <a:r>
                        <a:rPr lang="en-US" sz="12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mamid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ja-JP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8-12-2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uinolin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1-22-5 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methyl Sulfoxid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7-68-5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etrahydrofuran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9-99-9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propylene</a:t>
                      </a:r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Glycol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265-71-8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oluen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8-88-3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thanol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r>
                        <a:rPr lang="en-US" altLang="ja-JP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4-17-5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l-GR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γ-</a:t>
                      </a:r>
                      <a:r>
                        <a:rPr lang="en-US" sz="12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utyrolacton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6-48-0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3" name="テキスト ボックス 9"/>
          <p:cNvSpPr txBox="1"/>
          <p:nvPr/>
        </p:nvSpPr>
        <p:spPr>
          <a:xfrm>
            <a:off x="2970022" y="1185879"/>
            <a:ext cx="63619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Table </a:t>
            </a:r>
            <a:r>
              <a:rPr lang="en-US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1 List of solvents</a:t>
            </a:r>
            <a:endParaRPr lang="ja-JP" altLang="en-US" sz="2000" dirty="0"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7787610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85579430"/>
              </p:ext>
            </p:extLst>
          </p:nvPr>
        </p:nvGraphicFramePr>
        <p:xfrm>
          <a:off x="2460000" y="369332"/>
          <a:ext cx="7272000" cy="586740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792000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1620000"/>
                <a:gridCol w="1620000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1620000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1620000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</a:tblGrid>
              <a:tr h="30723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.</a:t>
                      </a:r>
                      <a:endParaRPr kumimoji="1" lang="ja-JP" altLang="en-US" sz="11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olymer</a:t>
                      </a:r>
                      <a:endParaRPr kumimoji="1" lang="ja-JP" altLang="en-US" sz="11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1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olymer concentration</a:t>
                      </a:r>
                    </a:p>
                    <a:p>
                      <a:pPr algn="ctr"/>
                      <a:r>
                        <a:rPr kumimoji="1" lang="en-US" altLang="ja-JP" sz="11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g]</a:t>
                      </a:r>
                      <a:endParaRPr kumimoji="1" lang="ja-JP" altLang="en-US" sz="11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1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rticle concentration</a:t>
                      </a:r>
                    </a:p>
                    <a:p>
                      <a:pPr algn="ctr"/>
                      <a:r>
                        <a:rPr kumimoji="1" lang="en-US" altLang="ja-JP" sz="11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g]</a:t>
                      </a:r>
                      <a:endParaRPr kumimoji="1" lang="ja-JP" altLang="en-US" sz="11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1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eating temperature</a:t>
                      </a:r>
                    </a:p>
                    <a:p>
                      <a:pPr algn="ctr"/>
                      <a:r>
                        <a:rPr kumimoji="1" lang="en-US" altLang="ja-JP" sz="11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</a:t>
                      </a:r>
                      <a:r>
                        <a:rPr kumimoji="1" lang="ja-JP" altLang="en-US" sz="11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℃</a:t>
                      </a:r>
                      <a:r>
                        <a:rPr kumimoji="1" lang="en-US" altLang="ja-JP" sz="11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]</a:t>
                      </a:r>
                      <a:endParaRPr kumimoji="1" lang="ja-JP" altLang="en-US" sz="11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25200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-A</a:t>
                      </a:r>
                      <a:endParaRPr kumimoji="1" lang="ja-JP" altLang="en-US" sz="11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1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0 g</a:t>
                      </a:r>
                      <a:endParaRPr lang="ja-JP" altLang="en-US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1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 g</a:t>
                      </a:r>
                      <a:endParaRPr lang="ja-JP" altLang="en-US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1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0 </a:t>
                      </a:r>
                      <a:r>
                        <a:rPr kumimoji="1" lang="ja-JP" altLang="en-US" sz="1100" b="0" baseline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℃</a:t>
                      </a:r>
                      <a:endParaRPr lang="ja-JP" altLang="en-US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25200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b="0" kern="12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</a:t>
                      </a:r>
                      <a:endParaRPr kumimoji="1" lang="ja-JP" altLang="en-US" sz="1100" b="0" kern="1200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1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-A</a:t>
                      </a:r>
                      <a:endParaRPr kumimoji="1" lang="ja-JP" altLang="en-US" sz="1100" b="0" kern="1200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b="0" baseline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g</a:t>
                      </a:r>
                      <a:endParaRPr kumimoji="1" lang="ja-JP" altLang="en-US" sz="1100" b="0" baseline="-25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1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 g</a:t>
                      </a:r>
                      <a:endParaRPr lang="ja-JP" altLang="en-US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1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0 </a:t>
                      </a:r>
                      <a:r>
                        <a:rPr kumimoji="1" lang="ja-JP" altLang="en-US" sz="1100" b="0" baseline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℃</a:t>
                      </a:r>
                      <a:endParaRPr lang="ja-JP" altLang="en-US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25200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b="0" kern="1200" baseline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</a:t>
                      </a:r>
                      <a:endParaRPr kumimoji="1" lang="ja-JP" altLang="en-US" sz="1100" b="0" kern="1200" baseline="0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1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-A</a:t>
                      </a:r>
                      <a:endParaRPr kumimoji="1" lang="ja-JP" altLang="en-US" sz="1100" b="0" kern="1200" baseline="0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b="0" baseline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</a:t>
                      </a:r>
                      <a:endParaRPr kumimoji="1" lang="ja-JP" altLang="en-US" sz="1100" b="0" baseline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1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 g</a:t>
                      </a:r>
                      <a:endParaRPr lang="ja-JP" altLang="en-US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1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0 </a:t>
                      </a:r>
                      <a:r>
                        <a:rPr kumimoji="1" lang="ja-JP" altLang="en-US" sz="1100" b="0" baseline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℃</a:t>
                      </a:r>
                      <a:endParaRPr lang="ja-JP" altLang="en-US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5200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b="0" kern="1200" baseline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</a:t>
                      </a:r>
                      <a:endParaRPr kumimoji="1" lang="ja-JP" altLang="en-US" sz="1100" b="0" kern="1200" baseline="0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-A</a:t>
                      </a:r>
                      <a:endParaRPr kumimoji="1" lang="ja-JP" altLang="en-US" sz="11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1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0 g</a:t>
                      </a:r>
                      <a:endParaRPr lang="ja-JP" altLang="en-US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1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 g</a:t>
                      </a:r>
                      <a:endParaRPr lang="ja-JP" altLang="en-US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1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0 </a:t>
                      </a:r>
                      <a:r>
                        <a:rPr kumimoji="1" lang="ja-JP" altLang="en-US" sz="1100" b="0" baseline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℃</a:t>
                      </a:r>
                      <a:endParaRPr lang="ja-JP" altLang="en-US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5200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b="0" kern="1200" baseline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5</a:t>
                      </a:r>
                      <a:endParaRPr kumimoji="1" lang="ja-JP" altLang="en-US" sz="1100" b="0" kern="1200" baseline="0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1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-A</a:t>
                      </a:r>
                      <a:endParaRPr kumimoji="1" lang="ja-JP" altLang="en-US" sz="1100" b="0" kern="1200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10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0 g</a:t>
                      </a:r>
                      <a:endParaRPr lang="ja-JP" altLang="en-US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1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 g</a:t>
                      </a:r>
                      <a:endParaRPr lang="ja-JP" altLang="en-US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1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0 </a:t>
                      </a:r>
                      <a:r>
                        <a:rPr kumimoji="1" lang="ja-JP" altLang="en-US" sz="1100" b="0" baseline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℃</a:t>
                      </a:r>
                      <a:endParaRPr lang="ja-JP" altLang="en-US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5200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b="0" kern="1200" baseline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6</a:t>
                      </a:r>
                      <a:endParaRPr kumimoji="1" lang="ja-JP" altLang="en-US" sz="1100" b="0" kern="1200" baseline="0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1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-A</a:t>
                      </a:r>
                      <a:endParaRPr kumimoji="1" lang="ja-JP" altLang="en-US" sz="1100" b="0" kern="1200" baseline="0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1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0 g</a:t>
                      </a:r>
                      <a:endParaRPr lang="ja-JP" altLang="en-US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1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 g</a:t>
                      </a:r>
                      <a:endParaRPr lang="ja-JP" altLang="en-US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1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 </a:t>
                      </a:r>
                      <a:r>
                        <a:rPr kumimoji="1" lang="ja-JP" altLang="en-US" sz="1100" b="0" baseline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℃</a:t>
                      </a:r>
                      <a:endParaRPr lang="ja-JP" altLang="en-US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5200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b="0" kern="1200" baseline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7</a:t>
                      </a:r>
                      <a:endParaRPr kumimoji="1" lang="ja-JP" altLang="en-US" sz="1100" b="0" kern="1200" baseline="0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-A</a:t>
                      </a:r>
                      <a:endParaRPr kumimoji="1" lang="ja-JP" altLang="en-US" sz="11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1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0 g</a:t>
                      </a:r>
                      <a:endParaRPr lang="ja-JP" altLang="en-US" sz="1100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1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</a:t>
                      </a:r>
                      <a:r>
                        <a:rPr lang="en-US" altLang="ja-JP" sz="1100" baseline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g</a:t>
                      </a:r>
                      <a:endParaRPr lang="ja-JP" altLang="en-US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1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0 </a:t>
                      </a:r>
                      <a:r>
                        <a:rPr kumimoji="1" lang="ja-JP" altLang="en-US" sz="1100" b="0" baseline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℃</a:t>
                      </a:r>
                      <a:endParaRPr lang="ja-JP" altLang="en-US" sz="1100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5200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b="0" kern="1200" baseline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8</a:t>
                      </a:r>
                      <a:endParaRPr kumimoji="1" lang="ja-JP" altLang="en-US" sz="1100" b="0" kern="1200" baseline="0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1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-B</a:t>
                      </a:r>
                      <a:endParaRPr kumimoji="1" lang="ja-JP" altLang="en-US" sz="1100" b="0" kern="1200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1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0 g</a:t>
                      </a:r>
                      <a:endParaRPr lang="ja-JP" altLang="en-US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1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 g</a:t>
                      </a:r>
                      <a:endParaRPr lang="ja-JP" altLang="en-US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1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0 </a:t>
                      </a:r>
                      <a:r>
                        <a:rPr kumimoji="1" lang="ja-JP" altLang="en-US" sz="1100" b="0" baseline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℃</a:t>
                      </a:r>
                      <a:endParaRPr lang="ja-JP" altLang="en-US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5200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b="0" kern="1200" baseline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9</a:t>
                      </a:r>
                      <a:endParaRPr kumimoji="1" lang="ja-JP" altLang="en-US" sz="1100" b="0" kern="1200" baseline="0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1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-B</a:t>
                      </a:r>
                      <a:endParaRPr kumimoji="1" lang="ja-JP" altLang="en-US" sz="1100" b="0" kern="1200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b="0" baseline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g</a:t>
                      </a:r>
                      <a:endParaRPr kumimoji="1" lang="ja-JP" altLang="en-US" sz="1100" b="0" baseline="-25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1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 g</a:t>
                      </a:r>
                      <a:endParaRPr lang="ja-JP" altLang="en-US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1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0 </a:t>
                      </a:r>
                      <a:r>
                        <a:rPr kumimoji="1" lang="ja-JP" altLang="en-US" sz="1100" b="0" baseline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℃</a:t>
                      </a:r>
                      <a:endParaRPr lang="ja-JP" altLang="en-US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5200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b="0" kern="1200" baseline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0</a:t>
                      </a:r>
                      <a:endParaRPr kumimoji="1" lang="ja-JP" altLang="en-US" sz="1100" b="0" kern="1200" baseline="0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1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-B</a:t>
                      </a:r>
                      <a:endParaRPr kumimoji="1" lang="ja-JP" altLang="en-US" sz="1100" b="0" kern="1200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b="0" baseline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</a:t>
                      </a:r>
                      <a:endParaRPr kumimoji="1" lang="ja-JP" altLang="en-US" sz="1100" b="0" baseline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1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 g</a:t>
                      </a:r>
                      <a:endParaRPr lang="ja-JP" altLang="en-US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1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0 </a:t>
                      </a:r>
                      <a:r>
                        <a:rPr kumimoji="1" lang="ja-JP" altLang="en-US" sz="1100" b="0" baseline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℃</a:t>
                      </a:r>
                      <a:endParaRPr lang="ja-JP" altLang="en-US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5200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b="0" kern="1200" baseline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1</a:t>
                      </a:r>
                      <a:endParaRPr kumimoji="1" lang="ja-JP" altLang="en-US" sz="1100" b="0" kern="1200" baseline="0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100" b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-B</a:t>
                      </a:r>
                      <a:endParaRPr kumimoji="1" lang="ja-JP" altLang="en-US" sz="1100" b="0" kern="1200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10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0 g</a:t>
                      </a:r>
                      <a:endParaRPr lang="ja-JP" altLang="en-US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1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 g</a:t>
                      </a:r>
                      <a:endParaRPr lang="ja-JP" altLang="en-US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1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0 </a:t>
                      </a:r>
                      <a:r>
                        <a:rPr kumimoji="1" lang="ja-JP" altLang="en-US" sz="1100" b="0" baseline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℃</a:t>
                      </a:r>
                      <a:endParaRPr lang="ja-JP" altLang="en-US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5200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b="0" kern="1200" baseline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2</a:t>
                      </a:r>
                      <a:endParaRPr kumimoji="1" lang="ja-JP" altLang="en-US" sz="1100" b="0" kern="1200" baseline="0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100" b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-B</a:t>
                      </a:r>
                      <a:endParaRPr kumimoji="1" lang="ja-JP" altLang="en-US" sz="1100" b="0" kern="1200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1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0 g</a:t>
                      </a:r>
                      <a:endParaRPr lang="ja-JP" altLang="en-US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1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 g</a:t>
                      </a:r>
                      <a:endParaRPr lang="ja-JP" altLang="en-US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1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0 </a:t>
                      </a:r>
                      <a:r>
                        <a:rPr kumimoji="1" lang="ja-JP" altLang="en-US" sz="1100" b="0" baseline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℃</a:t>
                      </a:r>
                      <a:endParaRPr lang="ja-JP" altLang="en-US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52000"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1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</a:t>
                      </a:r>
                      <a:endParaRPr lang="ja-JP" altLang="en-US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100" b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-B</a:t>
                      </a:r>
                      <a:endParaRPr kumimoji="1" lang="ja-JP" altLang="en-US" sz="1100" b="0" kern="1200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1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0 g</a:t>
                      </a:r>
                      <a:endParaRPr lang="ja-JP" altLang="en-US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1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 g</a:t>
                      </a:r>
                      <a:endParaRPr lang="ja-JP" altLang="en-US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1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 </a:t>
                      </a:r>
                      <a:r>
                        <a:rPr kumimoji="1" lang="ja-JP" altLang="en-US" sz="1100" b="0" baseline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℃</a:t>
                      </a:r>
                      <a:endParaRPr lang="ja-JP" altLang="en-US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52000"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1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</a:t>
                      </a:r>
                      <a:endParaRPr lang="ja-JP" altLang="en-US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1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-B</a:t>
                      </a:r>
                      <a:endParaRPr kumimoji="1" lang="ja-JP" altLang="en-US" sz="1100" b="0" kern="1200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1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0 g</a:t>
                      </a:r>
                      <a:endParaRPr lang="ja-JP" altLang="en-US" sz="1100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1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</a:t>
                      </a:r>
                      <a:r>
                        <a:rPr lang="en-US" altLang="ja-JP" sz="1100" baseline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g</a:t>
                      </a:r>
                      <a:endParaRPr lang="ja-JP" altLang="en-US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1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0 </a:t>
                      </a:r>
                      <a:r>
                        <a:rPr kumimoji="1" lang="ja-JP" altLang="en-US" sz="1100" b="0" baseline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℃</a:t>
                      </a:r>
                      <a:endParaRPr lang="ja-JP" altLang="en-US" sz="1100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52000"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1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</a:t>
                      </a:r>
                      <a:endParaRPr lang="ja-JP" altLang="en-US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100" smtClean="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</a:rPr>
                        <a:t>CEMEDINE C</a:t>
                      </a:r>
                      <a:endParaRPr kumimoji="1" lang="ja-JP" altLang="en-US" sz="1100" b="0" kern="1200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1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0 g</a:t>
                      </a:r>
                      <a:endParaRPr lang="ja-JP" altLang="en-US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1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 g</a:t>
                      </a:r>
                      <a:endParaRPr lang="ja-JP" altLang="en-US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1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0 </a:t>
                      </a:r>
                      <a:r>
                        <a:rPr kumimoji="1" lang="ja-JP" altLang="en-US" sz="1100" b="0" baseline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℃</a:t>
                      </a:r>
                      <a:endParaRPr lang="ja-JP" altLang="en-US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52000"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1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</a:t>
                      </a:r>
                      <a:endParaRPr lang="ja-JP" altLang="en-US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100" smtClean="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</a:rPr>
                        <a:t>CEMEDINE C</a:t>
                      </a:r>
                      <a:endParaRPr kumimoji="1" lang="ja-JP" altLang="en-US" sz="1100" b="0" kern="1200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b="0" baseline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g</a:t>
                      </a:r>
                      <a:endParaRPr kumimoji="1" lang="ja-JP" altLang="en-US" sz="1100" b="0" baseline="-25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1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 g</a:t>
                      </a:r>
                      <a:endParaRPr lang="ja-JP" altLang="en-US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1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0 </a:t>
                      </a:r>
                      <a:r>
                        <a:rPr kumimoji="1" lang="ja-JP" altLang="en-US" sz="1100" b="0" baseline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℃</a:t>
                      </a:r>
                      <a:endParaRPr lang="ja-JP" altLang="en-US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52000"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1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</a:t>
                      </a:r>
                      <a:endParaRPr lang="ja-JP" altLang="en-US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100" smtClean="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</a:rPr>
                        <a:t>CEMEDINE C</a:t>
                      </a:r>
                      <a:endParaRPr kumimoji="1" lang="ja-JP" altLang="en-US" sz="1100" b="0" kern="1200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b="0" baseline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</a:t>
                      </a:r>
                      <a:endParaRPr kumimoji="1" lang="ja-JP" altLang="en-US" sz="1100" b="0" baseline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1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 g</a:t>
                      </a:r>
                      <a:endParaRPr lang="ja-JP" altLang="en-US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1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0 </a:t>
                      </a:r>
                      <a:r>
                        <a:rPr kumimoji="1" lang="ja-JP" altLang="en-US" sz="1100" b="0" baseline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℃</a:t>
                      </a:r>
                      <a:endParaRPr lang="ja-JP" altLang="en-US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52000"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1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</a:t>
                      </a:r>
                      <a:endParaRPr lang="ja-JP" altLang="en-US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100" smtClean="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</a:rPr>
                        <a:t>CEMEDINE C</a:t>
                      </a:r>
                      <a:endParaRPr kumimoji="1" lang="ja-JP" altLang="en-US" sz="1100" b="0" kern="1200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10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0 g</a:t>
                      </a:r>
                      <a:endParaRPr lang="ja-JP" altLang="en-US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1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 g</a:t>
                      </a:r>
                      <a:endParaRPr lang="ja-JP" altLang="en-US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1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0 </a:t>
                      </a:r>
                      <a:r>
                        <a:rPr kumimoji="1" lang="ja-JP" altLang="en-US" sz="1100" b="0" baseline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℃</a:t>
                      </a:r>
                      <a:endParaRPr lang="ja-JP" altLang="en-US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52000"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1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</a:t>
                      </a:r>
                      <a:endParaRPr lang="ja-JP" altLang="en-US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100" smtClean="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</a:rPr>
                        <a:t>CEMEDINE C</a:t>
                      </a:r>
                      <a:endParaRPr kumimoji="1" lang="ja-JP" altLang="en-US" sz="1100" b="0" kern="1200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10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0 g</a:t>
                      </a:r>
                      <a:endParaRPr lang="ja-JP" altLang="en-US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1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 g</a:t>
                      </a:r>
                      <a:endParaRPr lang="ja-JP" altLang="en-US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1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0 </a:t>
                      </a:r>
                      <a:r>
                        <a:rPr kumimoji="1" lang="ja-JP" altLang="en-US" sz="1100" b="0" baseline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℃</a:t>
                      </a:r>
                      <a:endParaRPr lang="ja-JP" altLang="en-US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52000"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1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</a:t>
                      </a:r>
                      <a:endParaRPr lang="ja-JP" altLang="en-US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100" smtClean="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</a:rPr>
                        <a:t>CEMEDINE C</a:t>
                      </a:r>
                      <a:endParaRPr kumimoji="1" lang="ja-JP" altLang="en-US" sz="1100" b="0" kern="1200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1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0 g</a:t>
                      </a:r>
                      <a:endParaRPr lang="ja-JP" altLang="en-US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1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 g</a:t>
                      </a:r>
                      <a:endParaRPr lang="ja-JP" altLang="en-US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1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 </a:t>
                      </a:r>
                      <a:r>
                        <a:rPr kumimoji="1" lang="ja-JP" altLang="en-US" sz="1100" b="0" baseline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℃</a:t>
                      </a:r>
                      <a:endParaRPr lang="ja-JP" altLang="en-US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52000"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1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</a:t>
                      </a:r>
                      <a:endParaRPr lang="ja-JP" altLang="en-US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100" dirty="0" smtClean="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</a:rPr>
                        <a:t>CEMEDINE C</a:t>
                      </a:r>
                      <a:endParaRPr kumimoji="1" lang="ja-JP" altLang="en-US" sz="1100" b="0" kern="1200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1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0 g</a:t>
                      </a:r>
                      <a:endParaRPr lang="ja-JP" altLang="en-US" sz="1100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1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</a:t>
                      </a:r>
                      <a:r>
                        <a:rPr lang="en-US" altLang="ja-JP" sz="1100" baseline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g</a:t>
                      </a:r>
                      <a:endParaRPr lang="ja-JP" altLang="en-US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1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0 </a:t>
                      </a:r>
                      <a:r>
                        <a:rPr kumimoji="1" lang="ja-JP" altLang="en-US" sz="1100" b="0" baseline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℃</a:t>
                      </a:r>
                      <a:endParaRPr lang="ja-JP" altLang="en-US" sz="1100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" name="テキスト ボックス 3"/>
          <p:cNvSpPr txBox="1"/>
          <p:nvPr/>
        </p:nvSpPr>
        <p:spPr>
          <a:xfrm>
            <a:off x="4362865" y="0"/>
            <a:ext cx="34662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able </a:t>
            </a:r>
            <a:r>
              <a:rPr kumimoji="1" lang="en-US" altLang="ja-JP" sz="14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2</a:t>
            </a:r>
            <a:r>
              <a:rPr kumimoji="1" lang="ja-JP" altLang="en-US" sz="14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4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olymer </a:t>
            </a:r>
            <a:r>
              <a:rPr lang="en-US" altLang="ja-JP" sz="14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lm preparation conditions</a:t>
            </a:r>
            <a:endParaRPr kumimoji="1" lang="ja-JP" altLang="en-US" sz="1400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7558228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18641" y="518112"/>
            <a:ext cx="8436012" cy="4883193"/>
          </a:xfrm>
          <a:prstGeom prst="rect">
            <a:avLst/>
          </a:prstGeom>
        </p:spPr>
      </p:pic>
      <p:sp>
        <p:nvSpPr>
          <p:cNvPr id="3" name="テキスト ボックス 9"/>
          <p:cNvSpPr txBox="1"/>
          <p:nvPr/>
        </p:nvSpPr>
        <p:spPr>
          <a:xfrm>
            <a:off x="2755664" y="5618915"/>
            <a:ext cx="6361967" cy="4205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133" dirty="0" smtClean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Fig. S1 </a:t>
            </a:r>
            <a:r>
              <a:rPr lang="en-US" sz="2133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chematic of making process of polymer film.</a:t>
            </a:r>
            <a:endParaRPr lang="ja-JP" altLang="en-US" sz="2667" dirty="0"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7555963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図 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46836" y="269823"/>
            <a:ext cx="7211761" cy="5712894"/>
          </a:xfrm>
          <a:prstGeom prst="rect">
            <a:avLst/>
          </a:prstGeom>
        </p:spPr>
      </p:pic>
      <p:sp>
        <p:nvSpPr>
          <p:cNvPr id="9" name="テキスト ボックス 9"/>
          <p:cNvSpPr txBox="1"/>
          <p:nvPr/>
        </p:nvSpPr>
        <p:spPr>
          <a:xfrm>
            <a:off x="2830615" y="6128581"/>
            <a:ext cx="6361967" cy="4205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133" dirty="0" smtClean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Fig. S2 </a:t>
            </a:r>
            <a:r>
              <a:rPr lang="en-US" sz="2133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olymer preparation results</a:t>
            </a:r>
            <a:endParaRPr lang="ja-JP" altLang="en-US" sz="2667" dirty="0"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4900096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76</TotalTime>
  <Words>303</Words>
  <Application>Microsoft Office PowerPoint</Application>
  <PresentationFormat>ワイド画面</PresentationFormat>
  <Paragraphs>185</Paragraphs>
  <Slides>4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4</vt:i4>
      </vt:variant>
    </vt:vector>
  </HeadingPairs>
  <TitlesOfParts>
    <vt:vector size="9" baseType="lpstr">
      <vt:lpstr>ＭＳ Ｐゴシック</vt:lpstr>
      <vt:lpstr>ＭＳ 明朝</vt:lpstr>
      <vt:lpstr>Arial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pc</dc:creator>
  <cp:lastModifiedBy>pc</cp:lastModifiedBy>
  <cp:revision>11</cp:revision>
  <dcterms:created xsi:type="dcterms:W3CDTF">2018-11-30T09:11:14Z</dcterms:created>
  <dcterms:modified xsi:type="dcterms:W3CDTF">2019-09-28T08:18:47Z</dcterms:modified>
</cp:coreProperties>
</file>